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569" r:id="rId2"/>
    <p:sldId id="570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F0E38AB-E588-2D56-B555-66BE2EF94C65}" v="61" dt="2025-03-14T22:59:52.856"/>
    <p1510:client id="{E76B827F-F451-2C44-C775-0E1C40AF0124}" v="8" dt="2025-03-14T22:41:44.390"/>
    <p1510:client id="{F4AA52AA-1579-C8E9-4628-FE0192AF838B}" v="11" dt="2025-03-14T23:01:16.69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120" d="100"/>
          <a:sy n="120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nagi, Ioanna" userId="S::ip3917@ic.ac.uk::ddf0caa3-a47a-476b-9040-518f59755a05" providerId="AD" clId="Web-{E76B827F-F451-2C44-C775-0E1C40AF0124}"/>
    <pc:docChg chg="modSld">
      <pc:chgData name="Panagi, Ioanna" userId="S::ip3917@ic.ac.uk::ddf0caa3-a47a-476b-9040-518f59755a05" providerId="AD" clId="Web-{E76B827F-F451-2C44-C775-0E1C40AF0124}" dt="2025-03-14T22:41:44.390" v="7" actId="1076"/>
      <pc:docMkLst>
        <pc:docMk/>
      </pc:docMkLst>
      <pc:sldChg chg="addSp modSp">
        <pc:chgData name="Panagi, Ioanna" userId="S::ip3917@ic.ac.uk::ddf0caa3-a47a-476b-9040-518f59755a05" providerId="AD" clId="Web-{E76B827F-F451-2C44-C775-0E1C40AF0124}" dt="2025-03-14T22:41:44.390" v="7" actId="1076"/>
        <pc:sldMkLst>
          <pc:docMk/>
          <pc:sldMk cId="2948528659" sldId="570"/>
        </pc:sldMkLst>
        <pc:spChg chg="mod">
          <ac:chgData name="Panagi, Ioanna" userId="S::ip3917@ic.ac.uk::ddf0caa3-a47a-476b-9040-518f59755a05" providerId="AD" clId="Web-{E76B827F-F451-2C44-C775-0E1C40AF0124}" dt="2025-03-14T22:41:44.390" v="7" actId="1076"/>
          <ac:spMkLst>
            <pc:docMk/>
            <pc:sldMk cId="2948528659" sldId="570"/>
            <ac:spMk id="49" creationId="{6EF8AABC-46BD-53C5-5E20-392662D36EE2}"/>
          </ac:spMkLst>
        </pc:spChg>
        <pc:grpChg chg="add mod">
          <ac:chgData name="Panagi, Ioanna" userId="S::ip3917@ic.ac.uk::ddf0caa3-a47a-476b-9040-518f59755a05" providerId="AD" clId="Web-{E76B827F-F451-2C44-C775-0E1C40AF0124}" dt="2025-03-14T22:41:21.607" v="5" actId="1076"/>
          <ac:grpSpMkLst>
            <pc:docMk/>
            <pc:sldMk cId="2948528659" sldId="570"/>
            <ac:grpSpMk id="2" creationId="{878ED47B-A61E-3F46-5C65-F889B8BF67DC}"/>
          </ac:grpSpMkLst>
        </pc:grpChg>
        <pc:picChg chg="mod">
          <ac:chgData name="Panagi, Ioanna" userId="S::ip3917@ic.ac.uk::ddf0caa3-a47a-476b-9040-518f59755a05" providerId="AD" clId="Web-{E76B827F-F451-2C44-C775-0E1C40AF0124}" dt="2025-03-14T22:41:32.577" v="6" actId="1076"/>
          <ac:picMkLst>
            <pc:docMk/>
            <pc:sldMk cId="2948528659" sldId="570"/>
            <ac:picMk id="8" creationId="{B2533A39-2D77-804D-9399-DF1AAA3909D0}"/>
          </ac:picMkLst>
        </pc:picChg>
      </pc:sldChg>
    </pc:docChg>
  </pc:docChgLst>
  <pc:docChgLst>
    <pc:chgData name="Panagi, Ioanna" userId="S::ip3917@ic.ac.uk::ddf0caa3-a47a-476b-9040-518f59755a05" providerId="AD" clId="Web-{CF0E38AB-E588-2D56-B555-66BE2EF94C65}"/>
    <pc:docChg chg="modSld">
      <pc:chgData name="Panagi, Ioanna" userId="S::ip3917@ic.ac.uk::ddf0caa3-a47a-476b-9040-518f59755a05" providerId="AD" clId="Web-{CF0E38AB-E588-2D56-B555-66BE2EF94C65}" dt="2025-03-14T22:59:52.856" v="55" actId="1076"/>
      <pc:docMkLst>
        <pc:docMk/>
      </pc:docMkLst>
      <pc:sldChg chg="addSp delSp modSp">
        <pc:chgData name="Panagi, Ioanna" userId="S::ip3917@ic.ac.uk::ddf0caa3-a47a-476b-9040-518f59755a05" providerId="AD" clId="Web-{CF0E38AB-E588-2D56-B555-66BE2EF94C65}" dt="2025-03-14T22:59:52.856" v="55" actId="1076"/>
        <pc:sldMkLst>
          <pc:docMk/>
          <pc:sldMk cId="2948528659" sldId="570"/>
        </pc:sldMkLst>
        <pc:spChg chg="mod">
          <ac:chgData name="Panagi, Ioanna" userId="S::ip3917@ic.ac.uk::ddf0caa3-a47a-476b-9040-518f59755a05" providerId="AD" clId="Web-{CF0E38AB-E588-2D56-B555-66BE2EF94C65}" dt="2025-03-14T22:53:58.477" v="22" actId="1076"/>
          <ac:spMkLst>
            <pc:docMk/>
            <pc:sldMk cId="2948528659" sldId="570"/>
            <ac:spMk id="49" creationId="{6EF8AABC-46BD-53C5-5E20-392662D36EE2}"/>
          </ac:spMkLst>
        </pc:spChg>
        <pc:spChg chg="mod">
          <ac:chgData name="Panagi, Ioanna" userId="S::ip3917@ic.ac.uk::ddf0caa3-a47a-476b-9040-518f59755a05" providerId="AD" clId="Web-{CF0E38AB-E588-2D56-B555-66BE2EF94C65}" dt="2025-03-14T22:54:26.166" v="27" actId="1076"/>
          <ac:spMkLst>
            <pc:docMk/>
            <pc:sldMk cId="2948528659" sldId="570"/>
            <ac:spMk id="50" creationId="{071A281F-0E29-6DA3-7BC5-F8E1720D4ABB}"/>
          </ac:spMkLst>
        </pc:spChg>
        <pc:spChg chg="mod">
          <ac:chgData name="Panagi, Ioanna" userId="S::ip3917@ic.ac.uk::ddf0caa3-a47a-476b-9040-518f59755a05" providerId="AD" clId="Web-{CF0E38AB-E588-2D56-B555-66BE2EF94C65}" dt="2025-03-14T22:55:24.622" v="44" actId="1076"/>
          <ac:spMkLst>
            <pc:docMk/>
            <pc:sldMk cId="2948528659" sldId="570"/>
            <ac:spMk id="51" creationId="{1F6B99D2-19F8-E48A-88AB-B9DD61E5B088}"/>
          </ac:spMkLst>
        </pc:spChg>
        <pc:spChg chg="mod">
          <ac:chgData name="Panagi, Ioanna" userId="S::ip3917@ic.ac.uk::ddf0caa3-a47a-476b-9040-518f59755a05" providerId="AD" clId="Web-{CF0E38AB-E588-2D56-B555-66BE2EF94C65}" dt="2025-03-14T22:55:03.230" v="43" actId="1076"/>
          <ac:spMkLst>
            <pc:docMk/>
            <pc:sldMk cId="2948528659" sldId="570"/>
            <ac:spMk id="54" creationId="{AB651085-81D5-DF3A-E28E-E57B3D611170}"/>
          </ac:spMkLst>
        </pc:spChg>
        <pc:spChg chg="mod">
          <ac:chgData name="Panagi, Ioanna" userId="S::ip3917@ic.ac.uk::ddf0caa3-a47a-476b-9040-518f59755a05" providerId="AD" clId="Web-{CF0E38AB-E588-2D56-B555-66BE2EF94C65}" dt="2025-03-14T22:54:58.824" v="41" actId="1076"/>
          <ac:spMkLst>
            <pc:docMk/>
            <pc:sldMk cId="2948528659" sldId="570"/>
            <ac:spMk id="56" creationId="{70516E9B-E49F-F821-D9F0-4AE574C34A96}"/>
          </ac:spMkLst>
        </pc:spChg>
        <pc:spChg chg="mod">
          <ac:chgData name="Panagi, Ioanna" userId="S::ip3917@ic.ac.uk::ddf0caa3-a47a-476b-9040-518f59755a05" providerId="AD" clId="Web-{CF0E38AB-E588-2D56-B555-66BE2EF94C65}" dt="2025-03-14T22:54:55.027" v="39" actId="1076"/>
          <ac:spMkLst>
            <pc:docMk/>
            <pc:sldMk cId="2948528659" sldId="570"/>
            <ac:spMk id="59" creationId="{977A1412-9879-16EF-3FDD-99232DE7D37D}"/>
          </ac:spMkLst>
        </pc:spChg>
        <pc:spChg chg="mod">
          <ac:chgData name="Panagi, Ioanna" userId="S::ip3917@ic.ac.uk::ddf0caa3-a47a-476b-9040-518f59755a05" providerId="AD" clId="Web-{CF0E38AB-E588-2D56-B555-66BE2EF94C65}" dt="2025-03-14T22:54:48.104" v="37" actId="1076"/>
          <ac:spMkLst>
            <pc:docMk/>
            <pc:sldMk cId="2948528659" sldId="570"/>
            <ac:spMk id="61" creationId="{50B41220-920F-5AA2-8EE2-16AE90C9EBCF}"/>
          </ac:spMkLst>
        </pc:spChg>
        <pc:grpChg chg="mod">
          <ac:chgData name="Panagi, Ioanna" userId="S::ip3917@ic.ac.uk::ddf0caa3-a47a-476b-9040-518f59755a05" providerId="AD" clId="Web-{CF0E38AB-E588-2D56-B555-66BE2EF94C65}" dt="2025-03-14T22:56:56.299" v="48" actId="1076"/>
          <ac:grpSpMkLst>
            <pc:docMk/>
            <pc:sldMk cId="2948528659" sldId="570"/>
            <ac:grpSpMk id="2" creationId="{878ED47B-A61E-3F46-5C65-F889B8BF67DC}"/>
          </ac:grpSpMkLst>
        </pc:grpChg>
        <pc:grpChg chg="add mod">
          <ac:chgData name="Panagi, Ioanna" userId="S::ip3917@ic.ac.uk::ddf0caa3-a47a-476b-9040-518f59755a05" providerId="AD" clId="Web-{CF0E38AB-E588-2D56-B555-66BE2EF94C65}" dt="2025-03-14T22:59:52.856" v="55" actId="1076"/>
          <ac:grpSpMkLst>
            <pc:docMk/>
            <pc:sldMk cId="2948528659" sldId="570"/>
            <ac:grpSpMk id="9" creationId="{8211CBC9-EBB9-E1D9-00FA-4A17A644AA13}"/>
          </ac:grpSpMkLst>
        </pc:grpChg>
        <pc:grpChg chg="mod">
          <ac:chgData name="Panagi, Ioanna" userId="S::ip3917@ic.ac.uk::ddf0caa3-a47a-476b-9040-518f59755a05" providerId="AD" clId="Web-{CF0E38AB-E588-2D56-B555-66BE2EF94C65}" dt="2025-03-14T22:53:18.224" v="19" actId="1076"/>
          <ac:grpSpMkLst>
            <pc:docMk/>
            <pc:sldMk cId="2948528659" sldId="570"/>
            <ac:grpSpMk id="62" creationId="{288DB193-4C90-9488-B510-88C820337011}"/>
          </ac:grpSpMkLst>
        </pc:grpChg>
        <pc:picChg chg="add del mod">
          <ac:chgData name="Panagi, Ioanna" userId="S::ip3917@ic.ac.uk::ddf0caa3-a47a-476b-9040-518f59755a05" providerId="AD" clId="Web-{CF0E38AB-E588-2D56-B555-66BE2EF94C65}" dt="2025-03-14T22:51:52.720" v="3"/>
          <ac:picMkLst>
            <pc:docMk/>
            <pc:sldMk cId="2948528659" sldId="570"/>
            <ac:picMk id="6" creationId="{DB1A57AE-F6D3-C075-7676-AF56E8535E7F}"/>
          </ac:picMkLst>
        </pc:picChg>
        <pc:picChg chg="add mod ord modCrop">
          <ac:chgData name="Panagi, Ioanna" userId="S::ip3917@ic.ac.uk::ddf0caa3-a47a-476b-9040-518f59755a05" providerId="AD" clId="Web-{CF0E38AB-E588-2D56-B555-66BE2EF94C65}" dt="2025-03-14T22:57:26.035" v="50" actId="1076"/>
          <ac:picMkLst>
            <pc:docMk/>
            <pc:sldMk cId="2948528659" sldId="570"/>
            <ac:picMk id="7" creationId="{0A522451-C1DA-95BB-4E2B-86BA61EBA9BE}"/>
          </ac:picMkLst>
        </pc:picChg>
        <pc:picChg chg="mod">
          <ac:chgData name="Panagi, Ioanna" userId="S::ip3917@ic.ac.uk::ddf0caa3-a47a-476b-9040-518f59755a05" providerId="AD" clId="Web-{CF0E38AB-E588-2D56-B555-66BE2EF94C65}" dt="2025-03-14T22:53:54.101" v="21" actId="1076"/>
          <ac:picMkLst>
            <pc:docMk/>
            <pc:sldMk cId="2948528659" sldId="570"/>
            <ac:picMk id="8" creationId="{B2533A39-2D77-804D-9399-DF1AAA3909D0}"/>
          </ac:picMkLst>
        </pc:picChg>
        <pc:cxnChg chg="mod">
          <ac:chgData name="Panagi, Ioanna" userId="S::ip3917@ic.ac.uk::ddf0caa3-a47a-476b-9040-518f59755a05" providerId="AD" clId="Web-{CF0E38AB-E588-2D56-B555-66BE2EF94C65}" dt="2025-03-14T22:55:03.199" v="42" actId="1076"/>
          <ac:cxnSpMkLst>
            <pc:docMk/>
            <pc:sldMk cId="2948528659" sldId="570"/>
            <ac:cxnSpMk id="52" creationId="{555C4696-2FDB-CC83-96D7-46B552B8F8C6}"/>
          </ac:cxnSpMkLst>
        </pc:cxnChg>
        <pc:cxnChg chg="mod">
          <ac:chgData name="Panagi, Ioanna" userId="S::ip3917@ic.ac.uk::ddf0caa3-a47a-476b-9040-518f59755a05" providerId="AD" clId="Web-{CF0E38AB-E588-2D56-B555-66BE2EF94C65}" dt="2025-03-14T22:54:58.777" v="40" actId="1076"/>
          <ac:cxnSpMkLst>
            <pc:docMk/>
            <pc:sldMk cId="2948528659" sldId="570"/>
            <ac:cxnSpMk id="55" creationId="{E358D0A4-42ED-3A4A-DA55-05DE297724E2}"/>
          </ac:cxnSpMkLst>
        </pc:cxnChg>
        <pc:cxnChg chg="mod">
          <ac:chgData name="Panagi, Ioanna" userId="S::ip3917@ic.ac.uk::ddf0caa3-a47a-476b-9040-518f59755a05" providerId="AD" clId="Web-{CF0E38AB-E588-2D56-B555-66BE2EF94C65}" dt="2025-03-14T22:54:54.980" v="38" actId="1076"/>
          <ac:cxnSpMkLst>
            <pc:docMk/>
            <pc:sldMk cId="2948528659" sldId="570"/>
            <ac:cxnSpMk id="57" creationId="{E1916232-78F8-B852-E313-955A04B3E295}"/>
          </ac:cxnSpMkLst>
        </pc:cxnChg>
        <pc:cxnChg chg="mod">
          <ac:chgData name="Panagi, Ioanna" userId="S::ip3917@ic.ac.uk::ddf0caa3-a47a-476b-9040-518f59755a05" providerId="AD" clId="Web-{CF0E38AB-E588-2D56-B555-66BE2EF94C65}" dt="2025-03-14T22:54:48.057" v="36" actId="1076"/>
          <ac:cxnSpMkLst>
            <pc:docMk/>
            <pc:sldMk cId="2948528659" sldId="570"/>
            <ac:cxnSpMk id="60" creationId="{6A72BB14-4305-17AF-B1D2-2F57592C2F94}"/>
          </ac:cxnSpMkLst>
        </pc:cxnChg>
      </pc:sldChg>
    </pc:docChg>
  </pc:docChgLst>
  <pc:docChgLst>
    <pc:chgData name="Panagi, Ioanna" userId="S::ip3917@ic.ac.uk::ddf0caa3-a47a-476b-9040-518f59755a05" providerId="AD" clId="Web-{F4AA52AA-1579-C8E9-4628-FE0192AF838B}"/>
    <pc:docChg chg="modSld">
      <pc:chgData name="Panagi, Ioanna" userId="S::ip3917@ic.ac.uk::ddf0caa3-a47a-476b-9040-518f59755a05" providerId="AD" clId="Web-{F4AA52AA-1579-C8E9-4628-FE0192AF838B}" dt="2025-03-14T23:01:16.691" v="5" actId="1076"/>
      <pc:docMkLst>
        <pc:docMk/>
      </pc:docMkLst>
      <pc:sldChg chg="modSp">
        <pc:chgData name="Panagi, Ioanna" userId="S::ip3917@ic.ac.uk::ddf0caa3-a47a-476b-9040-518f59755a05" providerId="AD" clId="Web-{F4AA52AA-1579-C8E9-4628-FE0192AF838B}" dt="2025-03-14T23:01:16.691" v="5" actId="1076"/>
        <pc:sldMkLst>
          <pc:docMk/>
          <pc:sldMk cId="2948528659" sldId="570"/>
        </pc:sldMkLst>
        <pc:spChg chg="mod">
          <ac:chgData name="Panagi, Ioanna" userId="S::ip3917@ic.ac.uk::ddf0caa3-a47a-476b-9040-518f59755a05" providerId="AD" clId="Web-{F4AA52AA-1579-C8E9-4628-FE0192AF838B}" dt="2025-03-14T23:01:06.628" v="3" actId="20577"/>
          <ac:spMkLst>
            <pc:docMk/>
            <pc:sldMk cId="2948528659" sldId="570"/>
            <ac:spMk id="54" creationId="{AB651085-81D5-DF3A-E28E-E57B3D611170}"/>
          </ac:spMkLst>
        </pc:spChg>
        <pc:grpChg chg="mod">
          <ac:chgData name="Panagi, Ioanna" userId="S::ip3917@ic.ac.uk::ddf0caa3-a47a-476b-9040-518f59755a05" providerId="AD" clId="Web-{F4AA52AA-1579-C8E9-4628-FE0192AF838B}" dt="2025-03-14T23:01:16.691" v="5" actId="1076"/>
          <ac:grpSpMkLst>
            <pc:docMk/>
            <pc:sldMk cId="2948528659" sldId="570"/>
            <ac:grpSpMk id="9" creationId="{8211CBC9-EBB9-E1D9-00FA-4A17A644AA13}"/>
          </ac:grpSpMkLst>
        </pc:grpChg>
      </pc:sldChg>
    </pc:docChg>
  </pc:docChgLst>
  <pc:docChgLst>
    <pc:chgData clId="Web-{CF0E38AB-E588-2D56-B555-66BE2EF94C65}"/>
    <pc:docChg chg="modSld">
      <pc:chgData name="" userId="" providerId="" clId="Web-{CF0E38AB-E588-2D56-B555-66BE2EF94C65}" dt="2025-03-14T22:50:59.889" v="2"/>
      <pc:docMkLst>
        <pc:docMk/>
      </pc:docMkLst>
      <pc:sldChg chg="addSp delSp modSp">
        <pc:chgData name="" userId="" providerId="" clId="Web-{CF0E38AB-E588-2D56-B555-66BE2EF94C65}" dt="2025-03-14T22:50:59.889" v="2"/>
        <pc:sldMkLst>
          <pc:docMk/>
          <pc:sldMk cId="2948528659" sldId="570"/>
        </pc:sldMkLst>
        <pc:spChg chg="add del mod">
          <ac:chgData name="" userId="" providerId="" clId="Web-{CF0E38AB-E588-2D56-B555-66BE2EF94C65}" dt="2025-03-14T22:50:59.889" v="2"/>
          <ac:spMkLst>
            <pc:docMk/>
            <pc:sldMk cId="2948528659" sldId="570"/>
            <ac:spMk id="3" creationId="{BDA5C170-5D22-070D-4FEE-1F33292371B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FCA846-4F47-514A-AAEE-FD05E17B5B5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2D3D4A-FFEC-D744-BED7-9004525289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13665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74E4BA2-F2AA-AE47-B8F0-DFE5641E49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0AFBEEF-BF67-FE4B-B29F-458BECCE76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BFCD6A0-CAED-A84C-A38B-F14F088DD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EC1FD71-4357-584E-9896-E01EF2E7F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5A2999D-E073-7B48-B2D1-14B75DC4E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965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9C797CD-83B9-1D41-AD55-FCC672FC9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08C22D0-D50B-1740-9FC2-3836A79CA7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9CEBBB6-5DE5-3D41-A905-96ADBCB18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AAC4DAA-855E-0B40-A09A-FD5577821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F099258-2F0D-A54A-AB33-F2EDE0732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3745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6BE8874-D599-AB49-96D1-3AB52BAB44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BFA5AAB-F5D7-0C44-8D77-8FAFCB0C0C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C797E8F-87F6-B24B-AF65-6445BCEC5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5E54105-9757-414C-9C5B-7B3953AFA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158CEFE-1DF4-9746-8A29-7F6BBE010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4107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7C3AD4-3035-E64F-A8B1-29E974995A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8A321EA-4861-BE42-BE93-17972D44AF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AD8E30-9405-5149-BCED-339B9A3B1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48FACBF-A9AD-504E-BDCD-0E81C0B1F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1297AA2-F4E1-D347-88F7-8111C5788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5697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1B42D0B-FB29-D149-AC6A-13025D1EDF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282C7B2-EB84-F044-A864-0E397EEE6D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06C5AB2-6ED5-9747-914C-E7EF4A7EC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00CF31B-7BEF-7B49-BF39-CA25A4262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8087709-5A33-924C-90C0-4FE90D3DE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5421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63775E-B0BE-744D-A142-E699C5E4FF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174B3AB-DE57-0943-BAF9-5796860CFF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9F18A89-A55A-7044-94AB-AF1E4CC66B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A5808EE-8F04-E042-971E-B7576DE23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B30022D-965E-3E4C-81D9-4DE486CA6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83946F4-6291-1047-9618-8C1523747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4863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9D27CA9-93F7-3342-9D8A-B22A7D7FFF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5AD1498-6FC5-E040-9329-43FB06EE79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29CF3F1-030D-624D-B241-7B0964A727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A01B1AE-D872-7444-B014-D396B89C61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32A0BBB-18F0-0D4F-98F7-B53A5CFC51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CDE67C5-F70C-0D4E-8208-27BCF23D6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BF120DF-6966-8F41-AB32-95BAF9B28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27DC3108-1D3A-1145-B139-AEA4FAEA2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908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EDE3871-8B1F-7B4A-876A-4EF6167F14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6C4CE90-22C3-A44B-9FA2-0491E6C62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142B065-C2AC-4744-9BCF-3E5729944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0A6FC32-D690-C54C-901F-B8E2787D0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9322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860BC2C-8130-9B40-8601-A4A7868A5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0183179-A0FA-BB48-B9E7-CD8C11ADC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D2782FA-E46B-6247-BFBB-C3F7F4AABD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7104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52EAECE-4037-744F-B579-60A1706A85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43AF964-A02E-A448-8CD3-12E5FF6C42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036E6DE-818A-794A-92F7-B4854A2FC5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68CE8CF-9E6B-6746-A015-27671E969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53DBE09-9463-764B-A2BC-D9B271AE5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46A63FD-B8C2-D241-9436-4ADBE32BF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9934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B95ACA-DD51-034D-BA2A-C65941BB4B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3805E4A-5112-AE4F-A011-30F3AF8E95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84D8E4B-7AE5-DE4C-8AEE-8C6C03F974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518B980-7A29-D54E-9721-26DFD3233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9A4881E-AF9F-F548-8506-AD1E574D1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2080C45-EAC0-2746-8644-AAB720D1C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3242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C71166C-584B-7A4D-A505-E90551AEC7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BAD96A2-906F-6041-BC92-3F14F345E4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89B1B1-F0CE-0A4E-820B-A5F24BEB46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BD1EA18-72C0-4D46-B066-6BB971AC18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41766D8-BE28-134F-99E5-0B1CF11EE7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3325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B5A15F1-8D37-317F-C682-3C5001F7928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B5BD45D-7B54-6700-451E-382ED393E9EF}"/>
              </a:ext>
            </a:extLst>
          </p:cNvPr>
          <p:cNvSpPr txBox="1"/>
          <p:nvPr/>
        </p:nvSpPr>
        <p:spPr>
          <a:xfrm>
            <a:off x="9573209" y="0"/>
            <a:ext cx="26428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Source data for Figure 3H</a:t>
            </a:r>
          </a:p>
          <a:p>
            <a:r>
              <a:rPr lang="en-US" b="1"/>
              <a:t>HA + </a:t>
            </a:r>
            <a:r>
              <a:rPr lang="en-GB" b="1" err="1"/>
              <a:t>pTyrosine</a:t>
            </a:r>
            <a:r>
              <a:rPr lang="en-GB" b="1"/>
              <a:t> Blots</a:t>
            </a:r>
            <a:endParaRPr lang="en-US" b="1"/>
          </a:p>
        </p:txBody>
      </p:sp>
      <p:sp>
        <p:nvSpPr>
          <p:cNvPr id="5" name="ZoneTexte 10">
            <a:extLst>
              <a:ext uri="{FF2B5EF4-FFF2-40B4-BE49-F238E27FC236}">
                <a16:creationId xmlns:a16="http://schemas.microsoft.com/office/drawing/2014/main" id="{0212E07E-3E16-35EE-3622-E467D8CAFEC9}"/>
              </a:ext>
            </a:extLst>
          </p:cNvPr>
          <p:cNvSpPr txBox="1"/>
          <p:nvPr/>
        </p:nvSpPr>
        <p:spPr>
          <a:xfrm>
            <a:off x="9566622" y="1047644"/>
            <a:ext cx="252702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err="1"/>
              <a:t>Sample</a:t>
            </a:r>
            <a:r>
              <a:rPr lang="fr-FR" sz="1400" b="1"/>
              <a:t> Information</a:t>
            </a:r>
          </a:p>
          <a:p>
            <a:endParaRPr lang="fr-FR" sz="1400" b="1"/>
          </a:p>
          <a:p>
            <a:pPr marL="342900" indent="-342900">
              <a:buFont typeface="+mj-lt"/>
              <a:buAutoNum type="arabicPeriod"/>
            </a:pPr>
            <a:r>
              <a:rPr lang="fr-FR" sz="1400"/>
              <a:t>NI</a:t>
            </a:r>
          </a:p>
          <a:p>
            <a:pPr marL="342900" indent="-342900">
              <a:buFont typeface="+mj-lt"/>
              <a:buAutoNum type="arabicPeriod"/>
            </a:pPr>
            <a:r>
              <a:rPr lang="el-GR" sz="1400">
                <a:cs typeface="Arial" panose="020B0604020202020204" pitchFamily="34" charset="0"/>
              </a:rPr>
              <a:t>Δ</a:t>
            </a:r>
            <a:r>
              <a:rPr lang="en-GB" sz="1400" err="1">
                <a:cs typeface="Arial" panose="020B0604020202020204" pitchFamily="34" charset="0"/>
              </a:rPr>
              <a:t>steE</a:t>
            </a:r>
            <a:r>
              <a:rPr lang="en-GB" sz="1400">
                <a:cs typeface="Arial" panose="020B0604020202020204" pitchFamily="34" charset="0"/>
              </a:rPr>
              <a:t> + pSteE:2HA</a:t>
            </a:r>
          </a:p>
          <a:p>
            <a:pPr marL="342900" indent="-342900">
              <a:buFont typeface="+mj-lt"/>
              <a:buAutoNum type="arabicPeriod"/>
            </a:pPr>
            <a:r>
              <a:rPr lang="el-GR" sz="1400">
                <a:cs typeface="Arial" panose="020B0604020202020204" pitchFamily="34" charset="0"/>
              </a:rPr>
              <a:t>Δ</a:t>
            </a:r>
            <a:r>
              <a:rPr lang="en-GB" sz="1400" err="1">
                <a:cs typeface="Arial" panose="020B0604020202020204" pitchFamily="34" charset="0"/>
              </a:rPr>
              <a:t>steE</a:t>
            </a:r>
            <a:r>
              <a:rPr lang="en-GB" sz="1400">
                <a:cs typeface="Arial" panose="020B0604020202020204" pitchFamily="34" charset="0"/>
              </a:rPr>
              <a:t> + pSteE:2HA</a:t>
            </a:r>
            <a:r>
              <a:rPr lang="en-GB" sz="1400" baseline="30000">
                <a:cs typeface="Arial" panose="020B0604020202020204" pitchFamily="34" charset="0"/>
              </a:rPr>
              <a:t>L89A</a:t>
            </a:r>
            <a:endParaRPr lang="en-GB" sz="1400">
              <a:cs typeface="Arial" panose="020B0604020202020204" pitchFamily="34" charset="0"/>
            </a:endParaRPr>
          </a:p>
          <a:p>
            <a:endParaRPr lang="en-GB" sz="1400">
              <a:cs typeface="Arial" panose="020B0604020202020204" pitchFamily="34" charset="0"/>
            </a:endParaRPr>
          </a:p>
        </p:txBody>
      </p:sp>
      <p:grpSp>
        <p:nvGrpSpPr>
          <p:cNvPr id="66" name="Group 65">
            <a:extLst>
              <a:ext uri="{FF2B5EF4-FFF2-40B4-BE49-F238E27FC236}">
                <a16:creationId xmlns:a16="http://schemas.microsoft.com/office/drawing/2014/main" id="{4D7CED00-7E5D-1802-2E66-D7AA6E844CD9}"/>
              </a:ext>
            </a:extLst>
          </p:cNvPr>
          <p:cNvGrpSpPr/>
          <p:nvPr/>
        </p:nvGrpSpPr>
        <p:grpSpPr>
          <a:xfrm>
            <a:off x="5677087" y="92170"/>
            <a:ext cx="2671332" cy="2762800"/>
            <a:chOff x="6212767" y="233912"/>
            <a:chExt cx="2671332" cy="276280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69FB362-0500-1A45-84C3-DA98F10052B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38104" t="11628" r="38923" b="54464"/>
            <a:stretch/>
          </p:blipFill>
          <p:spPr>
            <a:xfrm>
              <a:off x="6212767" y="892370"/>
              <a:ext cx="1785541" cy="2104342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651FA10-0722-4B35-586C-7F17F8C9CD01}"/>
                </a:ext>
              </a:extLst>
            </p:cNvPr>
            <p:cNvSpPr txBox="1"/>
            <p:nvPr/>
          </p:nvSpPr>
          <p:spPr>
            <a:xfrm>
              <a:off x="6294159" y="233912"/>
              <a:ext cx="258994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1200"/>
                <a:t>α</a:t>
              </a:r>
              <a:r>
                <a:rPr lang="fr-FR" sz="1200"/>
                <a:t>-</a:t>
              </a:r>
              <a:r>
                <a:rPr lang="fr-FR" sz="1200" err="1"/>
                <a:t>pTyrosine</a:t>
              </a:r>
              <a:r>
                <a:rPr lang="fr-FR" sz="1200"/>
                <a:t> Blot</a:t>
              </a:r>
            </a:p>
            <a:p>
              <a:r>
                <a:rPr lang="fr-FR" sz="1200" err="1"/>
                <a:t>Chemiluminescence</a:t>
              </a:r>
              <a:r>
                <a:rPr lang="fr-FR" sz="1200"/>
                <a:t> image</a:t>
              </a:r>
              <a:endParaRPr lang="en-US" sz="120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F1F17CE-3635-7E77-EA44-0B44609D36D9}"/>
                </a:ext>
              </a:extLst>
            </p:cNvPr>
            <p:cNvSpPr txBox="1"/>
            <p:nvPr/>
          </p:nvSpPr>
          <p:spPr>
            <a:xfrm>
              <a:off x="6434379" y="112666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1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7EDB693F-7966-57B9-F275-5649EAF20123}"/>
                </a:ext>
              </a:extLst>
            </p:cNvPr>
            <p:cNvSpPr txBox="1"/>
            <p:nvPr/>
          </p:nvSpPr>
          <p:spPr>
            <a:xfrm>
              <a:off x="6612205" y="112666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2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8D05F0D-6B9C-14A4-EB52-41740C08EACD}"/>
                </a:ext>
              </a:extLst>
            </p:cNvPr>
            <p:cNvSpPr txBox="1"/>
            <p:nvPr/>
          </p:nvSpPr>
          <p:spPr>
            <a:xfrm>
              <a:off x="6824455" y="112666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3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F0CE222-B342-C289-AC5F-D1D5DDE9844A}"/>
                </a:ext>
              </a:extLst>
            </p:cNvPr>
            <p:cNvSpPr txBox="1"/>
            <p:nvPr/>
          </p:nvSpPr>
          <p:spPr>
            <a:xfrm>
              <a:off x="7036542" y="112666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1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F9FA7532-577A-F132-CF20-D41BBEBD9AEF}"/>
                </a:ext>
              </a:extLst>
            </p:cNvPr>
            <p:cNvSpPr txBox="1"/>
            <p:nvPr/>
          </p:nvSpPr>
          <p:spPr>
            <a:xfrm>
              <a:off x="7231479" y="112666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2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242D4699-00F9-769E-EAE2-DB21E87544CE}"/>
                </a:ext>
              </a:extLst>
            </p:cNvPr>
            <p:cNvSpPr txBox="1"/>
            <p:nvPr/>
          </p:nvSpPr>
          <p:spPr>
            <a:xfrm>
              <a:off x="7438286" y="112666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3</a:t>
              </a:r>
            </a:p>
          </p:txBody>
        </p:sp>
        <p:sp>
          <p:nvSpPr>
            <p:cNvPr id="47" name="ZoneTexte 32">
              <a:extLst>
                <a:ext uri="{FF2B5EF4-FFF2-40B4-BE49-F238E27FC236}">
                  <a16:creationId xmlns:a16="http://schemas.microsoft.com/office/drawing/2014/main" id="{53671CAD-DB76-0E8B-456F-69F0F6365DF2}"/>
                </a:ext>
              </a:extLst>
            </p:cNvPr>
            <p:cNvSpPr txBox="1"/>
            <p:nvPr/>
          </p:nvSpPr>
          <p:spPr>
            <a:xfrm>
              <a:off x="6448747" y="795929"/>
              <a:ext cx="684803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GB"/>
                <a:t>Input</a:t>
              </a:r>
              <a:endParaRPr lang="fr-FR"/>
            </a:p>
          </p:txBody>
        </p:sp>
        <p:sp>
          <p:nvSpPr>
            <p:cNvPr id="48" name="ZoneTexte 32">
              <a:extLst>
                <a:ext uri="{FF2B5EF4-FFF2-40B4-BE49-F238E27FC236}">
                  <a16:creationId xmlns:a16="http://schemas.microsoft.com/office/drawing/2014/main" id="{2A6567A1-6AE7-A413-6C8C-53C3852B4987}"/>
                </a:ext>
              </a:extLst>
            </p:cNvPr>
            <p:cNvSpPr txBox="1"/>
            <p:nvPr/>
          </p:nvSpPr>
          <p:spPr>
            <a:xfrm>
              <a:off x="7092613" y="795929"/>
              <a:ext cx="700833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/>
                <a:t>HA:IP</a:t>
              </a: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CEFF5AD0-5858-315A-7F29-35BCDA9F9119}"/>
                </a:ext>
              </a:extLst>
            </p:cNvPr>
            <p:cNvSpPr/>
            <p:nvPr/>
          </p:nvSpPr>
          <p:spPr>
            <a:xfrm flipV="1">
              <a:off x="6293449" y="2201719"/>
              <a:ext cx="1499997" cy="418712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DA102449-C4C7-983A-861D-C15EF442B040}"/>
              </a:ext>
            </a:extLst>
          </p:cNvPr>
          <p:cNvGrpSpPr/>
          <p:nvPr/>
        </p:nvGrpSpPr>
        <p:grpSpPr>
          <a:xfrm>
            <a:off x="5410050" y="2653400"/>
            <a:ext cx="2313778" cy="3982470"/>
            <a:chOff x="5863767" y="2543477"/>
            <a:chExt cx="2313778" cy="3982470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C0ACBCAB-5C9C-19B8-B356-70CF5E4F24C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8102" t="2379" r="11846" b="51323"/>
            <a:stretch/>
          </p:blipFill>
          <p:spPr>
            <a:xfrm>
              <a:off x="6348031" y="3212865"/>
              <a:ext cx="1573631" cy="2583584"/>
            </a:xfrm>
            <a:prstGeom prst="rect">
              <a:avLst/>
            </a:prstGeom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DECE546C-AF5C-924C-E5A0-1A19B9C72B47}"/>
                </a:ext>
              </a:extLst>
            </p:cNvPr>
            <p:cNvSpPr txBox="1"/>
            <p:nvPr/>
          </p:nvSpPr>
          <p:spPr>
            <a:xfrm rot="18528072">
              <a:off x="6209477" y="2753471"/>
              <a:ext cx="7585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>
                  <a:solidFill>
                    <a:srgbClr val="C00000"/>
                  </a:solidFill>
                </a:rPr>
                <a:t>Ladder</a:t>
              </a:r>
            </a:p>
          </p:txBody>
        </p:sp>
        <p:sp>
          <p:nvSpPr>
            <p:cNvPr id="51" name="ZoneTexte 32">
              <a:extLst>
                <a:ext uri="{FF2B5EF4-FFF2-40B4-BE49-F238E27FC236}">
                  <a16:creationId xmlns:a16="http://schemas.microsoft.com/office/drawing/2014/main" id="{74725D50-8A25-1E71-5153-2929558E5CA6}"/>
                </a:ext>
              </a:extLst>
            </p:cNvPr>
            <p:cNvSpPr txBox="1"/>
            <p:nvPr/>
          </p:nvSpPr>
          <p:spPr>
            <a:xfrm>
              <a:off x="6286963" y="5879616"/>
              <a:ext cx="189058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/>
                <a:t>α</a:t>
              </a:r>
              <a:r>
                <a:rPr lang="fr-FR" sz="1200"/>
                <a:t>-</a:t>
              </a:r>
              <a:r>
                <a:rPr lang="en-GB" sz="1200" err="1"/>
                <a:t>pTyrosine</a:t>
              </a:r>
              <a:endParaRPr lang="fr-FR" sz="1200"/>
            </a:p>
            <a:p>
              <a:r>
                <a:rPr lang="fr-FR" sz="1200" err="1"/>
                <a:t>Chemiluminescence</a:t>
              </a:r>
              <a:r>
                <a:rPr lang="fr-FR" sz="1200"/>
                <a:t> image </a:t>
              </a:r>
              <a:br>
                <a:rPr lang="el-GR" sz="1200"/>
              </a:br>
              <a:r>
                <a:rPr lang="fr-FR" sz="1200"/>
                <a:t>+ Membrane overlay</a:t>
              </a: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B3597972-A535-F215-2AE1-3BC5EB0312ED}"/>
                </a:ext>
              </a:extLst>
            </p:cNvPr>
            <p:cNvCxnSpPr>
              <a:cxnSpLocks/>
            </p:cNvCxnSpPr>
            <p:nvPr/>
          </p:nvCxnSpPr>
          <p:spPr>
            <a:xfrm>
              <a:off x="6222785" y="5105230"/>
              <a:ext cx="20896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76A7061-1A5D-7A05-D2E8-31ACBB884147}"/>
                </a:ext>
              </a:extLst>
            </p:cNvPr>
            <p:cNvSpPr txBox="1"/>
            <p:nvPr/>
          </p:nvSpPr>
          <p:spPr>
            <a:xfrm>
              <a:off x="5865523" y="4935953"/>
              <a:ext cx="4956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/>
                <a:t>25</a:t>
              </a: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A77CBFCC-14CA-6423-B75A-398B13234D90}"/>
                </a:ext>
              </a:extLst>
            </p:cNvPr>
            <p:cNvCxnSpPr>
              <a:cxnSpLocks/>
            </p:cNvCxnSpPr>
            <p:nvPr/>
          </p:nvCxnSpPr>
          <p:spPr>
            <a:xfrm>
              <a:off x="6224220" y="4840533"/>
              <a:ext cx="20896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35AAF0FE-8030-68C5-82EF-0DFD1CF40666}"/>
                </a:ext>
              </a:extLst>
            </p:cNvPr>
            <p:cNvSpPr txBox="1"/>
            <p:nvPr/>
          </p:nvSpPr>
          <p:spPr>
            <a:xfrm>
              <a:off x="5866958" y="4671256"/>
              <a:ext cx="4956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/>
                <a:t>37</a:t>
              </a:r>
            </a:p>
          </p:txBody>
        </p: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601FD3FF-C391-FC58-BC2E-6D1271356A3E}"/>
                </a:ext>
              </a:extLst>
            </p:cNvPr>
            <p:cNvCxnSpPr>
              <a:cxnSpLocks/>
            </p:cNvCxnSpPr>
            <p:nvPr/>
          </p:nvCxnSpPr>
          <p:spPr>
            <a:xfrm>
              <a:off x="6222785" y="4546959"/>
              <a:ext cx="20896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612CCA09-41A5-CE14-51FF-6BA43618D389}"/>
                </a:ext>
              </a:extLst>
            </p:cNvPr>
            <p:cNvSpPr txBox="1"/>
            <p:nvPr/>
          </p:nvSpPr>
          <p:spPr>
            <a:xfrm>
              <a:off x="5865523" y="4377682"/>
              <a:ext cx="4956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/>
                <a:t>50</a:t>
              </a: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0DA3B3DB-358B-898A-05E1-97A7C7A62335}"/>
                </a:ext>
              </a:extLst>
            </p:cNvPr>
            <p:cNvCxnSpPr>
              <a:cxnSpLocks/>
            </p:cNvCxnSpPr>
            <p:nvPr/>
          </p:nvCxnSpPr>
          <p:spPr>
            <a:xfrm>
              <a:off x="6221029" y="4196484"/>
              <a:ext cx="20896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E8B9E54F-A0D6-9E78-6BB3-746220D84B88}"/>
                </a:ext>
              </a:extLst>
            </p:cNvPr>
            <p:cNvSpPr txBox="1"/>
            <p:nvPr/>
          </p:nvSpPr>
          <p:spPr>
            <a:xfrm>
              <a:off x="5863767" y="4027207"/>
              <a:ext cx="4956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/>
                <a:t>75</a:t>
              </a:r>
            </a:p>
          </p:txBody>
        </p:sp>
      </p:grpSp>
      <p:pic>
        <p:nvPicPr>
          <p:cNvPr id="68" name="Picture 67">
            <a:extLst>
              <a:ext uri="{FF2B5EF4-FFF2-40B4-BE49-F238E27FC236}">
                <a16:creationId xmlns:a16="http://schemas.microsoft.com/office/drawing/2014/main" id="{FF7F6962-8158-A42E-445A-1B111BAE247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3306" t="54226" r="65539" b="12630"/>
          <a:stretch/>
        </p:blipFill>
        <p:spPr>
          <a:xfrm>
            <a:off x="2654208" y="788573"/>
            <a:ext cx="1644198" cy="2056930"/>
          </a:xfrm>
          <a:prstGeom prst="rect">
            <a:avLst/>
          </a:prstGeom>
        </p:spPr>
      </p:pic>
      <p:sp>
        <p:nvSpPr>
          <p:cNvPr id="72" name="Rectangle 71">
            <a:extLst>
              <a:ext uri="{FF2B5EF4-FFF2-40B4-BE49-F238E27FC236}">
                <a16:creationId xmlns:a16="http://schemas.microsoft.com/office/drawing/2014/main" id="{E184804A-D917-AD88-9E55-B9C2D2925359}"/>
              </a:ext>
            </a:extLst>
          </p:cNvPr>
          <p:cNvSpPr/>
          <p:nvPr/>
        </p:nvSpPr>
        <p:spPr>
          <a:xfrm flipV="1">
            <a:off x="2830285" y="2049778"/>
            <a:ext cx="1548803" cy="418712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9FFDA87-3890-CB44-72A6-B69B87EBD467}"/>
              </a:ext>
            </a:extLst>
          </p:cNvPr>
          <p:cNvSpPr txBox="1"/>
          <p:nvPr/>
        </p:nvSpPr>
        <p:spPr>
          <a:xfrm>
            <a:off x="2684562" y="143123"/>
            <a:ext cx="258994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sz="1200"/>
              <a:t>α</a:t>
            </a:r>
            <a:r>
              <a:rPr lang="fr-FR" sz="1200"/>
              <a:t>-HA Blot</a:t>
            </a:r>
          </a:p>
          <a:p>
            <a:r>
              <a:rPr lang="fr-FR" sz="1200" err="1"/>
              <a:t>Chemiluminescence</a:t>
            </a:r>
            <a:r>
              <a:rPr lang="fr-FR" sz="1200"/>
              <a:t> image</a:t>
            </a:r>
            <a:endParaRPr lang="en-US" sz="120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12D10F6-1D86-A449-9251-50934BDE523B}"/>
              </a:ext>
            </a:extLst>
          </p:cNvPr>
          <p:cNvSpPr txBox="1"/>
          <p:nvPr/>
        </p:nvSpPr>
        <p:spPr>
          <a:xfrm>
            <a:off x="2867148" y="104220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1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CE58989-BA4D-704A-F873-4750D688D98D}"/>
              </a:ext>
            </a:extLst>
          </p:cNvPr>
          <p:cNvSpPr txBox="1"/>
          <p:nvPr/>
        </p:nvSpPr>
        <p:spPr>
          <a:xfrm>
            <a:off x="3044974" y="104220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2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6A0842F-B59E-BBAF-8FED-9CFDC8A82BB2}"/>
              </a:ext>
            </a:extLst>
          </p:cNvPr>
          <p:cNvSpPr txBox="1"/>
          <p:nvPr/>
        </p:nvSpPr>
        <p:spPr>
          <a:xfrm>
            <a:off x="3257224" y="104220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3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EE9747C-6DC1-2EF3-1A62-28D38B61B359}"/>
              </a:ext>
            </a:extLst>
          </p:cNvPr>
          <p:cNvSpPr txBox="1"/>
          <p:nvPr/>
        </p:nvSpPr>
        <p:spPr>
          <a:xfrm>
            <a:off x="3469311" y="104220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1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404E69F-BBD8-F101-909C-8C403FC495B5}"/>
              </a:ext>
            </a:extLst>
          </p:cNvPr>
          <p:cNvSpPr txBox="1"/>
          <p:nvPr/>
        </p:nvSpPr>
        <p:spPr>
          <a:xfrm>
            <a:off x="3664248" y="104220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2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9FD92EBC-34F0-ECE4-0565-8EDC69CEA916}"/>
              </a:ext>
            </a:extLst>
          </p:cNvPr>
          <p:cNvSpPr txBox="1"/>
          <p:nvPr/>
        </p:nvSpPr>
        <p:spPr>
          <a:xfrm>
            <a:off x="3871055" y="104220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3</a:t>
            </a:r>
          </a:p>
        </p:txBody>
      </p:sp>
      <p:sp>
        <p:nvSpPr>
          <p:cNvPr id="89" name="ZoneTexte 32">
            <a:extLst>
              <a:ext uri="{FF2B5EF4-FFF2-40B4-BE49-F238E27FC236}">
                <a16:creationId xmlns:a16="http://schemas.microsoft.com/office/drawing/2014/main" id="{36ABBAA8-12DF-E0BA-D5A1-A4E15A53AEC8}"/>
              </a:ext>
            </a:extLst>
          </p:cNvPr>
          <p:cNvSpPr txBox="1"/>
          <p:nvPr/>
        </p:nvSpPr>
        <p:spPr>
          <a:xfrm>
            <a:off x="2881516" y="711473"/>
            <a:ext cx="684803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/>
              <a:t>Input</a:t>
            </a:r>
            <a:endParaRPr lang="fr-FR"/>
          </a:p>
        </p:txBody>
      </p:sp>
      <p:sp>
        <p:nvSpPr>
          <p:cNvPr id="90" name="ZoneTexte 32">
            <a:extLst>
              <a:ext uri="{FF2B5EF4-FFF2-40B4-BE49-F238E27FC236}">
                <a16:creationId xmlns:a16="http://schemas.microsoft.com/office/drawing/2014/main" id="{3A6054BC-9C6F-2A90-CA53-4FC31093D8C8}"/>
              </a:ext>
            </a:extLst>
          </p:cNvPr>
          <p:cNvSpPr txBox="1"/>
          <p:nvPr/>
        </p:nvSpPr>
        <p:spPr>
          <a:xfrm>
            <a:off x="3525382" y="711473"/>
            <a:ext cx="700833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fr-FR"/>
              <a:t>HA:IP</a:t>
            </a:r>
          </a:p>
        </p:txBody>
      </p:sp>
      <p:pic>
        <p:nvPicPr>
          <p:cNvPr id="97" name="Picture 96">
            <a:extLst>
              <a:ext uri="{FF2B5EF4-FFF2-40B4-BE49-F238E27FC236}">
                <a16:creationId xmlns:a16="http://schemas.microsoft.com/office/drawing/2014/main" id="{DFE8146F-A674-B0C0-04A2-C31DC77AEECE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13173"/>
          <a:stretch/>
        </p:blipFill>
        <p:spPr>
          <a:xfrm>
            <a:off x="2785164" y="3343546"/>
            <a:ext cx="2016952" cy="2682047"/>
          </a:xfrm>
          <a:prstGeom prst="rect">
            <a:avLst/>
          </a:prstGeom>
        </p:spPr>
      </p:pic>
      <p:sp>
        <p:nvSpPr>
          <p:cNvPr id="99" name="TextBox 98">
            <a:extLst>
              <a:ext uri="{FF2B5EF4-FFF2-40B4-BE49-F238E27FC236}">
                <a16:creationId xmlns:a16="http://schemas.microsoft.com/office/drawing/2014/main" id="{70683DA3-AF3A-436C-C983-8085E87FC7DA}"/>
              </a:ext>
            </a:extLst>
          </p:cNvPr>
          <p:cNvSpPr txBox="1"/>
          <p:nvPr/>
        </p:nvSpPr>
        <p:spPr>
          <a:xfrm rot="18528072">
            <a:off x="2784695" y="2866538"/>
            <a:ext cx="7585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solidFill>
                  <a:srgbClr val="C00000"/>
                </a:solidFill>
              </a:rPr>
              <a:t>Ladder</a:t>
            </a:r>
          </a:p>
        </p:txBody>
      </p:sp>
      <p:sp>
        <p:nvSpPr>
          <p:cNvPr id="100" name="ZoneTexte 32">
            <a:extLst>
              <a:ext uri="{FF2B5EF4-FFF2-40B4-BE49-F238E27FC236}">
                <a16:creationId xmlns:a16="http://schemas.microsoft.com/office/drawing/2014/main" id="{01855BEC-9E93-729E-853C-734FF4F144F0}"/>
              </a:ext>
            </a:extLst>
          </p:cNvPr>
          <p:cNvSpPr txBox="1"/>
          <p:nvPr/>
        </p:nvSpPr>
        <p:spPr>
          <a:xfrm>
            <a:off x="2848349" y="6024413"/>
            <a:ext cx="18905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/>
              <a:t>α</a:t>
            </a:r>
            <a:r>
              <a:rPr lang="fr-FR" sz="1200"/>
              <a:t>-</a:t>
            </a:r>
            <a:r>
              <a:rPr lang="en-GB" sz="1200"/>
              <a:t>HA</a:t>
            </a:r>
            <a:endParaRPr lang="fr-FR" sz="1200"/>
          </a:p>
          <a:p>
            <a:r>
              <a:rPr lang="fr-FR" sz="1200" err="1"/>
              <a:t>Chemiluminescence</a:t>
            </a:r>
            <a:r>
              <a:rPr lang="fr-FR" sz="1200"/>
              <a:t> image </a:t>
            </a:r>
            <a:br>
              <a:rPr lang="el-GR" sz="1200"/>
            </a:br>
            <a:r>
              <a:rPr lang="fr-FR" sz="1200"/>
              <a:t>+ Membrane overlay</a:t>
            </a:r>
          </a:p>
        </p:txBody>
      </p: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44BE6DF5-7EE8-DB57-7AF5-267B3997F148}"/>
              </a:ext>
            </a:extLst>
          </p:cNvPr>
          <p:cNvCxnSpPr>
            <a:cxnSpLocks/>
          </p:cNvCxnSpPr>
          <p:nvPr/>
        </p:nvCxnSpPr>
        <p:spPr>
          <a:xfrm>
            <a:off x="2806518" y="5229316"/>
            <a:ext cx="20896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4" name="TextBox 113">
            <a:extLst>
              <a:ext uri="{FF2B5EF4-FFF2-40B4-BE49-F238E27FC236}">
                <a16:creationId xmlns:a16="http://schemas.microsoft.com/office/drawing/2014/main" id="{634ECA15-F559-4124-7521-92FD1ACFADE2}"/>
              </a:ext>
            </a:extLst>
          </p:cNvPr>
          <p:cNvSpPr txBox="1"/>
          <p:nvPr/>
        </p:nvSpPr>
        <p:spPr>
          <a:xfrm>
            <a:off x="2449256" y="5060039"/>
            <a:ext cx="4956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/>
              <a:t>25</a:t>
            </a:r>
          </a:p>
        </p:txBody>
      </p: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6017C9BA-7E05-03FC-94F6-344975490268}"/>
              </a:ext>
            </a:extLst>
          </p:cNvPr>
          <p:cNvCxnSpPr>
            <a:cxnSpLocks/>
          </p:cNvCxnSpPr>
          <p:nvPr/>
        </p:nvCxnSpPr>
        <p:spPr>
          <a:xfrm>
            <a:off x="2807235" y="4815473"/>
            <a:ext cx="20896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id="{0073A56F-5C24-3D4B-7EFF-A36B07AB9C57}"/>
              </a:ext>
            </a:extLst>
          </p:cNvPr>
          <p:cNvSpPr txBox="1"/>
          <p:nvPr/>
        </p:nvSpPr>
        <p:spPr>
          <a:xfrm>
            <a:off x="2449973" y="4646196"/>
            <a:ext cx="4956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/>
              <a:t>37</a:t>
            </a:r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2EC72295-641C-0090-15A4-A2F3070D6FA2}"/>
              </a:ext>
            </a:extLst>
          </p:cNvPr>
          <p:cNvCxnSpPr>
            <a:cxnSpLocks/>
          </p:cNvCxnSpPr>
          <p:nvPr/>
        </p:nvCxnSpPr>
        <p:spPr>
          <a:xfrm>
            <a:off x="2807952" y="4457479"/>
            <a:ext cx="20896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4747AE01-5613-0A79-C2FE-5E07D74DE000}"/>
              </a:ext>
            </a:extLst>
          </p:cNvPr>
          <p:cNvSpPr txBox="1"/>
          <p:nvPr/>
        </p:nvSpPr>
        <p:spPr>
          <a:xfrm>
            <a:off x="2450690" y="4288202"/>
            <a:ext cx="4956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/>
              <a:t>50</a:t>
            </a:r>
          </a:p>
        </p:txBody>
      </p: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C6CDC073-86DA-24ED-5C36-21B4732CEE36}"/>
              </a:ext>
            </a:extLst>
          </p:cNvPr>
          <p:cNvCxnSpPr>
            <a:cxnSpLocks/>
          </p:cNvCxnSpPr>
          <p:nvPr/>
        </p:nvCxnSpPr>
        <p:spPr>
          <a:xfrm>
            <a:off x="2808669" y="4052901"/>
            <a:ext cx="208961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F15E9D95-F94C-6C63-A5F4-0859C959A1DB}"/>
              </a:ext>
            </a:extLst>
          </p:cNvPr>
          <p:cNvSpPr txBox="1"/>
          <p:nvPr/>
        </p:nvSpPr>
        <p:spPr>
          <a:xfrm>
            <a:off x="2451407" y="3883624"/>
            <a:ext cx="4956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/>
              <a:t>75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AFA4370A-6927-08E0-749B-B78AE5026E82}"/>
              </a:ext>
            </a:extLst>
          </p:cNvPr>
          <p:cNvSpPr txBox="1"/>
          <p:nvPr/>
        </p:nvSpPr>
        <p:spPr>
          <a:xfrm>
            <a:off x="2213014" y="3268186"/>
            <a:ext cx="5020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err="1"/>
              <a:t>kDa</a:t>
            </a:r>
            <a:endParaRPr lang="en-US" sz="160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6579F089-D290-6D99-63AD-395721F19765}"/>
              </a:ext>
            </a:extLst>
          </p:cNvPr>
          <p:cNvSpPr txBox="1"/>
          <p:nvPr/>
        </p:nvSpPr>
        <p:spPr>
          <a:xfrm>
            <a:off x="5347153" y="3268186"/>
            <a:ext cx="5020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err="1"/>
              <a:t>kDa</a:t>
            </a:r>
            <a:endParaRPr lang="en-US" sz="1600"/>
          </a:p>
        </p:txBody>
      </p:sp>
    </p:spTree>
    <p:extLst>
      <p:ext uri="{BB962C8B-B14F-4D97-AF65-F5344CB8AC3E}">
        <p14:creationId xmlns:p14="http://schemas.microsoft.com/office/powerpoint/2010/main" val="9240626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7A615FB-7612-7259-8289-2D6CCF19ACA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4827460-79DB-D9AD-1930-7FCF30F0BD9E}"/>
              </a:ext>
            </a:extLst>
          </p:cNvPr>
          <p:cNvSpPr txBox="1"/>
          <p:nvPr/>
        </p:nvSpPr>
        <p:spPr>
          <a:xfrm>
            <a:off x="9573209" y="0"/>
            <a:ext cx="26428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ource data for Figure 3H</a:t>
            </a:r>
          </a:p>
          <a:p>
            <a:r>
              <a:rPr lang="en-GB" b="1" dirty="0"/>
              <a:t>GSK3</a:t>
            </a:r>
            <a:r>
              <a:rPr lang="el-GR" b="1" dirty="0"/>
              <a:t>α/β</a:t>
            </a:r>
            <a:r>
              <a:rPr lang="en-GB" b="1" dirty="0"/>
              <a:t> + STAT3</a:t>
            </a:r>
            <a:endParaRPr lang="en-US" b="1" dirty="0"/>
          </a:p>
        </p:txBody>
      </p:sp>
      <p:sp>
        <p:nvSpPr>
          <p:cNvPr id="5" name="ZoneTexte 10">
            <a:extLst>
              <a:ext uri="{FF2B5EF4-FFF2-40B4-BE49-F238E27FC236}">
                <a16:creationId xmlns:a16="http://schemas.microsoft.com/office/drawing/2014/main" id="{FBE5F6E5-2243-D548-A6D8-E599BE60C3DB}"/>
              </a:ext>
            </a:extLst>
          </p:cNvPr>
          <p:cNvSpPr txBox="1"/>
          <p:nvPr/>
        </p:nvSpPr>
        <p:spPr>
          <a:xfrm>
            <a:off x="9566622" y="1047644"/>
            <a:ext cx="252702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err="1"/>
              <a:t>Sample</a:t>
            </a:r>
            <a:r>
              <a:rPr lang="fr-FR" sz="1400" b="1"/>
              <a:t> Information</a:t>
            </a:r>
          </a:p>
          <a:p>
            <a:endParaRPr lang="fr-FR" sz="1400" b="1"/>
          </a:p>
          <a:p>
            <a:pPr marL="342900" indent="-342900">
              <a:buFont typeface="+mj-lt"/>
              <a:buAutoNum type="arabicPeriod"/>
            </a:pPr>
            <a:r>
              <a:rPr lang="fr-FR" sz="1400"/>
              <a:t>NI</a:t>
            </a:r>
          </a:p>
          <a:p>
            <a:pPr marL="342900" indent="-342900">
              <a:buFont typeface="+mj-lt"/>
              <a:buAutoNum type="arabicPeriod"/>
            </a:pPr>
            <a:r>
              <a:rPr lang="el-GR" sz="1400">
                <a:cs typeface="Arial" panose="020B0604020202020204" pitchFamily="34" charset="0"/>
              </a:rPr>
              <a:t>Δ</a:t>
            </a:r>
            <a:r>
              <a:rPr lang="en-GB" sz="1400" err="1">
                <a:cs typeface="Arial" panose="020B0604020202020204" pitchFamily="34" charset="0"/>
              </a:rPr>
              <a:t>steE</a:t>
            </a:r>
            <a:r>
              <a:rPr lang="en-GB" sz="1400">
                <a:cs typeface="Arial" panose="020B0604020202020204" pitchFamily="34" charset="0"/>
              </a:rPr>
              <a:t> + pSteE:2HA</a:t>
            </a:r>
          </a:p>
          <a:p>
            <a:pPr marL="342900" indent="-342900">
              <a:buFont typeface="+mj-lt"/>
              <a:buAutoNum type="arabicPeriod"/>
            </a:pPr>
            <a:r>
              <a:rPr lang="el-GR" sz="1400">
                <a:cs typeface="Arial" panose="020B0604020202020204" pitchFamily="34" charset="0"/>
              </a:rPr>
              <a:t>Δ</a:t>
            </a:r>
            <a:r>
              <a:rPr lang="en-GB" sz="1400" err="1">
                <a:cs typeface="Arial" panose="020B0604020202020204" pitchFamily="34" charset="0"/>
              </a:rPr>
              <a:t>steE</a:t>
            </a:r>
            <a:r>
              <a:rPr lang="en-GB" sz="1400">
                <a:cs typeface="Arial" panose="020B0604020202020204" pitchFamily="34" charset="0"/>
              </a:rPr>
              <a:t> + pSteE:2HA</a:t>
            </a:r>
            <a:r>
              <a:rPr lang="en-GB" sz="1400" baseline="30000">
                <a:cs typeface="Arial" panose="020B0604020202020204" pitchFamily="34" charset="0"/>
              </a:rPr>
              <a:t>L89A</a:t>
            </a:r>
            <a:endParaRPr lang="en-GB" sz="1400">
              <a:cs typeface="Arial" panose="020B0604020202020204" pitchFamily="34" charset="0"/>
            </a:endParaRPr>
          </a:p>
          <a:p>
            <a:endParaRPr lang="en-GB" sz="1400">
              <a:cs typeface="Arial" panose="020B0604020202020204" pitchFamily="34" charset="0"/>
            </a:endParaRPr>
          </a:p>
        </p:txBody>
      </p:sp>
      <p:grpSp>
        <p:nvGrpSpPr>
          <p:cNvPr id="64" name="Group 63">
            <a:extLst>
              <a:ext uri="{FF2B5EF4-FFF2-40B4-BE49-F238E27FC236}">
                <a16:creationId xmlns:a16="http://schemas.microsoft.com/office/drawing/2014/main" id="{99D23871-B900-1D4C-95A5-60B8CA07C388}"/>
              </a:ext>
            </a:extLst>
          </p:cNvPr>
          <p:cNvGrpSpPr/>
          <p:nvPr/>
        </p:nvGrpSpPr>
        <p:grpSpPr>
          <a:xfrm>
            <a:off x="2143355" y="337241"/>
            <a:ext cx="2671081" cy="2694363"/>
            <a:chOff x="3442266" y="147576"/>
            <a:chExt cx="2671081" cy="2694363"/>
          </a:xfrm>
        </p:grpSpPr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0E954987-A00C-2A2E-DD53-7F2CD6680D6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36939" t="53389" r="41907" b="10128"/>
            <a:stretch/>
          </p:blipFill>
          <p:spPr>
            <a:xfrm>
              <a:off x="3442266" y="577775"/>
              <a:ext cx="1644198" cy="2264164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B4A7224-3973-CA9E-17E1-76C60B954BAE}"/>
                </a:ext>
              </a:extLst>
            </p:cNvPr>
            <p:cNvSpPr txBox="1"/>
            <p:nvPr/>
          </p:nvSpPr>
          <p:spPr>
            <a:xfrm>
              <a:off x="3525725" y="97145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D2BE18C-9E12-73D4-10FA-73736189505C}"/>
                </a:ext>
              </a:extLst>
            </p:cNvPr>
            <p:cNvSpPr txBox="1"/>
            <p:nvPr/>
          </p:nvSpPr>
          <p:spPr>
            <a:xfrm>
              <a:off x="3736209" y="97145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2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087DBB8-8720-B204-8519-279E950CEAE1}"/>
                </a:ext>
              </a:extLst>
            </p:cNvPr>
            <p:cNvSpPr txBox="1"/>
            <p:nvPr/>
          </p:nvSpPr>
          <p:spPr>
            <a:xfrm>
              <a:off x="3948459" y="97145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3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50D56E5-B74F-FEA7-02B0-9F434C8D6EA6}"/>
                </a:ext>
              </a:extLst>
            </p:cNvPr>
            <p:cNvSpPr txBox="1"/>
            <p:nvPr/>
          </p:nvSpPr>
          <p:spPr>
            <a:xfrm>
              <a:off x="4138774" y="97145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52C5762-89CF-9F6F-AE48-3031CA36C5F5}"/>
                </a:ext>
              </a:extLst>
            </p:cNvPr>
            <p:cNvSpPr txBox="1"/>
            <p:nvPr/>
          </p:nvSpPr>
          <p:spPr>
            <a:xfrm>
              <a:off x="4339154" y="97145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2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1E8142B-B6CC-70ED-7563-2BEF4A6448CD}"/>
                </a:ext>
              </a:extLst>
            </p:cNvPr>
            <p:cNvSpPr txBox="1"/>
            <p:nvPr/>
          </p:nvSpPr>
          <p:spPr>
            <a:xfrm>
              <a:off x="4551404" y="97145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3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8E565C4B-0DF8-7EA7-0B97-30829FE0F1D4}"/>
                </a:ext>
              </a:extLst>
            </p:cNvPr>
            <p:cNvSpPr/>
            <p:nvPr/>
          </p:nvSpPr>
          <p:spPr>
            <a:xfrm flipV="1">
              <a:off x="3523407" y="1370627"/>
              <a:ext cx="1446523" cy="418712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CA5680F-2A02-5076-B6AC-98E7EA60C4EF}"/>
                </a:ext>
              </a:extLst>
            </p:cNvPr>
            <p:cNvSpPr txBox="1"/>
            <p:nvPr/>
          </p:nvSpPr>
          <p:spPr>
            <a:xfrm>
              <a:off x="3523407" y="147576"/>
              <a:ext cx="258994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1200"/>
                <a:t>α</a:t>
              </a:r>
              <a:r>
                <a:rPr lang="fr-FR" sz="1200"/>
                <a:t>-GSK3</a:t>
              </a:r>
              <a:r>
                <a:rPr lang="el-GR" sz="1200"/>
                <a:t>α/β</a:t>
              </a:r>
              <a:r>
                <a:rPr lang="fr-FR" sz="1200"/>
                <a:t> Blot</a:t>
              </a:r>
            </a:p>
            <a:p>
              <a:r>
                <a:rPr lang="fr-FR" sz="1200" err="1"/>
                <a:t>Chemiluminescence</a:t>
              </a:r>
              <a:r>
                <a:rPr lang="fr-FR" sz="1200"/>
                <a:t> image</a:t>
              </a:r>
              <a:endParaRPr lang="en-US" sz="1200"/>
            </a:p>
          </p:txBody>
        </p:sp>
        <p:sp>
          <p:nvSpPr>
            <p:cNvPr id="23" name="ZoneTexte 32">
              <a:extLst>
                <a:ext uri="{FF2B5EF4-FFF2-40B4-BE49-F238E27FC236}">
                  <a16:creationId xmlns:a16="http://schemas.microsoft.com/office/drawing/2014/main" id="{02843C18-5E63-DF2D-675C-50B5EE346ACC}"/>
                </a:ext>
              </a:extLst>
            </p:cNvPr>
            <p:cNvSpPr txBox="1"/>
            <p:nvPr/>
          </p:nvSpPr>
          <p:spPr>
            <a:xfrm>
              <a:off x="3561865" y="640727"/>
              <a:ext cx="684803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GB"/>
                <a:t>Input</a:t>
              </a:r>
              <a:endParaRPr lang="fr-FR"/>
            </a:p>
          </p:txBody>
        </p:sp>
        <p:sp>
          <p:nvSpPr>
            <p:cNvPr id="24" name="ZoneTexte 32">
              <a:extLst>
                <a:ext uri="{FF2B5EF4-FFF2-40B4-BE49-F238E27FC236}">
                  <a16:creationId xmlns:a16="http://schemas.microsoft.com/office/drawing/2014/main" id="{C06C3899-4F16-1216-1449-9FFD77D43B8B}"/>
                </a:ext>
              </a:extLst>
            </p:cNvPr>
            <p:cNvSpPr txBox="1"/>
            <p:nvPr/>
          </p:nvSpPr>
          <p:spPr>
            <a:xfrm>
              <a:off x="4183959" y="640727"/>
              <a:ext cx="700833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/>
                <a:t>HA:IP</a:t>
              </a:r>
            </a:p>
          </p:txBody>
        </p: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D2658A1C-CB43-EFDD-1170-6A018E2F9B31}"/>
              </a:ext>
            </a:extLst>
          </p:cNvPr>
          <p:cNvGrpSpPr/>
          <p:nvPr/>
        </p:nvGrpSpPr>
        <p:grpSpPr>
          <a:xfrm>
            <a:off x="1701739" y="2499693"/>
            <a:ext cx="2677007" cy="4124678"/>
            <a:chOff x="2968360" y="2501941"/>
            <a:chExt cx="2677007" cy="4124678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58B450AC-FA4C-DB94-BBA3-E57401B6C90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34583" y="3212865"/>
              <a:ext cx="1630327" cy="2457748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E97096D-E8CA-BD31-0B1E-FE69F2CAE3AD}"/>
                </a:ext>
              </a:extLst>
            </p:cNvPr>
            <p:cNvSpPr txBox="1"/>
            <p:nvPr/>
          </p:nvSpPr>
          <p:spPr>
            <a:xfrm rot="18528072">
              <a:off x="3346781" y="2711935"/>
              <a:ext cx="7585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>
                  <a:solidFill>
                    <a:srgbClr val="C00000"/>
                  </a:solidFill>
                </a:rPr>
                <a:t>Ladder</a:t>
              </a: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00BC32F6-CC71-6017-9318-2E9901D1EEAE}"/>
                </a:ext>
              </a:extLst>
            </p:cNvPr>
            <p:cNvCxnSpPr>
              <a:cxnSpLocks/>
            </p:cNvCxnSpPr>
            <p:nvPr/>
          </p:nvCxnSpPr>
          <p:spPr>
            <a:xfrm>
              <a:off x="3325622" y="4103089"/>
              <a:ext cx="20896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0855199-C473-E882-9602-A258B757E34A}"/>
                </a:ext>
              </a:extLst>
            </p:cNvPr>
            <p:cNvSpPr txBox="1"/>
            <p:nvPr/>
          </p:nvSpPr>
          <p:spPr>
            <a:xfrm>
              <a:off x="2968360" y="3933812"/>
              <a:ext cx="4956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/>
                <a:t>75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511F2352-3906-1588-3E33-E21F86CB5819}"/>
                </a:ext>
              </a:extLst>
            </p:cNvPr>
            <p:cNvCxnSpPr>
              <a:cxnSpLocks/>
            </p:cNvCxnSpPr>
            <p:nvPr/>
          </p:nvCxnSpPr>
          <p:spPr>
            <a:xfrm>
              <a:off x="3329430" y="4425087"/>
              <a:ext cx="20896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83B18FB-C1CC-CE54-6338-F171834F870B}"/>
                </a:ext>
              </a:extLst>
            </p:cNvPr>
            <p:cNvSpPr txBox="1"/>
            <p:nvPr/>
          </p:nvSpPr>
          <p:spPr>
            <a:xfrm>
              <a:off x="2972168" y="4255810"/>
              <a:ext cx="4956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/>
                <a:t>50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CE8CC5A2-DB1B-5C48-E725-489BFDA1E15E}"/>
                </a:ext>
              </a:extLst>
            </p:cNvPr>
            <p:cNvCxnSpPr>
              <a:cxnSpLocks/>
            </p:cNvCxnSpPr>
            <p:nvPr/>
          </p:nvCxnSpPr>
          <p:spPr>
            <a:xfrm>
              <a:off x="3325622" y="4998768"/>
              <a:ext cx="208961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864546D-0993-AA11-6A1F-109BBD6A5CF4}"/>
                </a:ext>
              </a:extLst>
            </p:cNvPr>
            <p:cNvSpPr txBox="1"/>
            <p:nvPr/>
          </p:nvSpPr>
          <p:spPr>
            <a:xfrm>
              <a:off x="2968360" y="4829491"/>
              <a:ext cx="4956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/>
                <a:t>25</a:t>
              </a:r>
            </a:p>
          </p:txBody>
        </p:sp>
        <p:sp>
          <p:nvSpPr>
            <p:cNvPr id="38" name="ZoneTexte 32">
              <a:extLst>
                <a:ext uri="{FF2B5EF4-FFF2-40B4-BE49-F238E27FC236}">
                  <a16:creationId xmlns:a16="http://schemas.microsoft.com/office/drawing/2014/main" id="{8D567BDE-E9AB-3FD9-C6C1-B357029F5EA5}"/>
                </a:ext>
              </a:extLst>
            </p:cNvPr>
            <p:cNvSpPr txBox="1"/>
            <p:nvPr/>
          </p:nvSpPr>
          <p:spPr>
            <a:xfrm>
              <a:off x="3356471" y="5795622"/>
              <a:ext cx="2288896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/>
                <a:t>α</a:t>
              </a:r>
              <a:r>
                <a:rPr lang="fr-FR" sz="1200"/>
                <a:t>-</a:t>
              </a:r>
              <a:r>
                <a:rPr lang="en-GB" sz="1200"/>
                <a:t>GSK3</a:t>
              </a:r>
              <a:r>
                <a:rPr lang="el-GR" sz="1200"/>
                <a:t>α/β</a:t>
              </a:r>
              <a:r>
                <a:rPr lang="fr-FR" sz="1200"/>
                <a:t> Blot</a:t>
              </a:r>
            </a:p>
            <a:p>
              <a:r>
                <a:rPr lang="fr-FR" sz="1200" err="1"/>
                <a:t>Chemiluminescence</a:t>
              </a:r>
              <a:r>
                <a:rPr lang="fr-FR" sz="1200"/>
                <a:t> image </a:t>
              </a:r>
              <a:br>
                <a:rPr lang="el-GR" sz="1200"/>
              </a:br>
              <a:r>
                <a:rPr lang="fr-FR" sz="1200"/>
                <a:t>+ Membrane overlay</a:t>
              </a:r>
            </a:p>
            <a:p>
              <a:r>
                <a:rPr lang="fr-FR" sz="1200">
                  <a:sym typeface="Wingdings" pitchFamily="2" charset="2"/>
                </a:rPr>
                <a:t> Ladder </a:t>
              </a:r>
              <a:r>
                <a:rPr lang="fr-FR" sz="1200" err="1">
                  <a:sym typeface="Wingdings" pitchFamily="2" charset="2"/>
                </a:rPr>
                <a:t>cut</a:t>
              </a:r>
              <a:r>
                <a:rPr lang="fr-FR" sz="1200">
                  <a:sym typeface="Wingdings" pitchFamily="2" charset="2"/>
                </a:rPr>
                <a:t> </a:t>
              </a:r>
              <a:r>
                <a:rPr lang="fr-FR" sz="1200" err="1">
                  <a:sym typeface="Wingdings" pitchFamily="2" charset="2"/>
                </a:rPr>
                <a:t>halfway</a:t>
              </a:r>
              <a:r>
                <a:rPr lang="fr-FR" sz="1200">
                  <a:sym typeface="Wingdings" pitchFamily="2" charset="2"/>
                </a:rPr>
                <a:t> (</a:t>
              </a:r>
              <a:r>
                <a:rPr lang="fr-FR" sz="1200" err="1">
                  <a:sym typeface="Wingdings" pitchFamily="2" charset="2"/>
                </a:rPr>
                <a:t>vertically</a:t>
              </a:r>
              <a:r>
                <a:rPr lang="fr-FR" sz="1200">
                  <a:sym typeface="Wingdings" pitchFamily="2" charset="2"/>
                </a:rPr>
                <a:t>)</a:t>
              </a:r>
              <a:r>
                <a:rPr lang="fr-FR" sz="1200"/>
                <a:t> 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878ED47B-A61E-3F46-5C65-F889B8BF67DC}"/>
              </a:ext>
            </a:extLst>
          </p:cNvPr>
          <p:cNvGrpSpPr/>
          <p:nvPr/>
        </p:nvGrpSpPr>
        <p:grpSpPr>
          <a:xfrm>
            <a:off x="5744774" y="224546"/>
            <a:ext cx="2630544" cy="3033896"/>
            <a:chOff x="6521213" y="124497"/>
            <a:chExt cx="2630544" cy="3033896"/>
          </a:xfrm>
        </p:grpSpPr>
        <p:pic>
          <p:nvPicPr>
            <p:cNvPr id="8" name="Picture 7" descr="A close-up of a dna test&#10;&#10;AI-generated content may be incorrect.">
              <a:extLst>
                <a:ext uri="{FF2B5EF4-FFF2-40B4-BE49-F238E27FC236}">
                  <a16:creationId xmlns:a16="http://schemas.microsoft.com/office/drawing/2014/main" id="{B2533A39-2D77-804D-9399-DF1AAA3909D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36271" t="7353" r="40112" b="55170"/>
            <a:stretch/>
          </p:blipFill>
          <p:spPr>
            <a:xfrm>
              <a:off x="6521213" y="928067"/>
              <a:ext cx="1759990" cy="2230326"/>
            </a:xfrm>
            <a:prstGeom prst="rect">
              <a:avLst/>
            </a:prstGeom>
          </p:spPr>
        </p:pic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A53C6903-D611-A410-C83B-07200B358956}"/>
                </a:ext>
              </a:extLst>
            </p:cNvPr>
            <p:cNvGrpSpPr/>
            <p:nvPr/>
          </p:nvGrpSpPr>
          <p:grpSpPr>
            <a:xfrm>
              <a:off x="6561107" y="124497"/>
              <a:ext cx="2590650" cy="1814324"/>
              <a:chOff x="6293449" y="233912"/>
              <a:chExt cx="2590650" cy="1814324"/>
            </a:xfrm>
          </p:grpSpPr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9EFDD872-ED38-F9EA-0C7D-8DCBE6A7828B}"/>
                  </a:ext>
                </a:extLst>
              </p:cNvPr>
              <p:cNvSpPr txBox="1"/>
              <p:nvPr/>
            </p:nvSpPr>
            <p:spPr>
              <a:xfrm>
                <a:off x="6294159" y="233912"/>
                <a:ext cx="2589940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l-GR" sz="1200"/>
                  <a:t>α</a:t>
                </a:r>
                <a:r>
                  <a:rPr lang="fr-FR" sz="1200"/>
                  <a:t>-STAT3 Blot</a:t>
                </a:r>
              </a:p>
              <a:p>
                <a:r>
                  <a:rPr lang="fr-FR" sz="1200" err="1"/>
                  <a:t>Chemiluminescence</a:t>
                </a:r>
                <a:r>
                  <a:rPr lang="fr-FR" sz="1200"/>
                  <a:t> image</a:t>
                </a:r>
                <a:endParaRPr lang="en-US" sz="1200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C0AEC500-ABC8-CFBC-387F-7307B4459E5F}"/>
                  </a:ext>
                </a:extLst>
              </p:cNvPr>
              <p:cNvSpPr txBox="1"/>
              <p:nvPr/>
            </p:nvSpPr>
            <p:spPr>
              <a:xfrm>
                <a:off x="6492744" y="1126660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/>
                  <a:t>1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88655393-D5F9-05BF-0333-734840023348}"/>
                  </a:ext>
                </a:extLst>
              </p:cNvPr>
              <p:cNvSpPr txBox="1"/>
              <p:nvPr/>
            </p:nvSpPr>
            <p:spPr>
              <a:xfrm>
                <a:off x="6696510" y="1126660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/>
                  <a:t>2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BCB903B3-9BFC-5582-7DA2-C2802CA353B2}"/>
                  </a:ext>
                </a:extLst>
              </p:cNvPr>
              <p:cNvSpPr txBox="1"/>
              <p:nvPr/>
            </p:nvSpPr>
            <p:spPr>
              <a:xfrm>
                <a:off x="6869850" y="1126660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/>
                  <a:t>3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7A634875-D659-817F-F196-14989000C771}"/>
                  </a:ext>
                </a:extLst>
              </p:cNvPr>
              <p:cNvSpPr txBox="1"/>
              <p:nvPr/>
            </p:nvSpPr>
            <p:spPr>
              <a:xfrm>
                <a:off x="7055997" y="1126660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/>
                  <a:t>1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A5CF2909-A365-F06F-A632-FE5F82E61298}"/>
                  </a:ext>
                </a:extLst>
              </p:cNvPr>
              <p:cNvSpPr txBox="1"/>
              <p:nvPr/>
            </p:nvSpPr>
            <p:spPr>
              <a:xfrm>
                <a:off x="7224994" y="1126660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/>
                  <a:t>2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8F7787C6-26C0-7534-F53D-1F75F5EDBE5F}"/>
                  </a:ext>
                </a:extLst>
              </p:cNvPr>
              <p:cNvSpPr txBox="1"/>
              <p:nvPr/>
            </p:nvSpPr>
            <p:spPr>
              <a:xfrm>
                <a:off x="7418831" y="1126660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/>
                  <a:t>3</a:t>
                </a:r>
              </a:p>
            </p:txBody>
          </p:sp>
          <p:sp>
            <p:nvSpPr>
              <p:cNvPr id="47" name="ZoneTexte 32">
                <a:extLst>
                  <a:ext uri="{FF2B5EF4-FFF2-40B4-BE49-F238E27FC236}">
                    <a16:creationId xmlns:a16="http://schemas.microsoft.com/office/drawing/2014/main" id="{F7F49E57-4E22-54C6-36C9-214501104F7C}"/>
                  </a:ext>
                </a:extLst>
              </p:cNvPr>
              <p:cNvSpPr txBox="1"/>
              <p:nvPr/>
            </p:nvSpPr>
            <p:spPr>
              <a:xfrm>
                <a:off x="6448747" y="795929"/>
                <a:ext cx="684803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/>
                  <a:t>Input</a:t>
                </a:r>
                <a:endParaRPr lang="fr-FR"/>
              </a:p>
            </p:txBody>
          </p:sp>
          <p:sp>
            <p:nvSpPr>
              <p:cNvPr id="48" name="ZoneTexte 32">
                <a:extLst>
                  <a:ext uri="{FF2B5EF4-FFF2-40B4-BE49-F238E27FC236}">
                    <a16:creationId xmlns:a16="http://schemas.microsoft.com/office/drawing/2014/main" id="{1F6DE89B-2A05-3FE5-19B4-E321ABC476AE}"/>
                  </a:ext>
                </a:extLst>
              </p:cNvPr>
              <p:cNvSpPr txBox="1"/>
              <p:nvPr/>
            </p:nvSpPr>
            <p:spPr>
              <a:xfrm>
                <a:off x="7092613" y="795929"/>
                <a:ext cx="700833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fr-FR"/>
                  <a:t>HA:IP</a:t>
                </a:r>
              </a:p>
            </p:txBody>
          </p:sp>
          <p:sp>
            <p:nvSpPr>
              <p:cNvPr id="49" name="Rectangle 48">
                <a:extLst>
                  <a:ext uri="{FF2B5EF4-FFF2-40B4-BE49-F238E27FC236}">
                    <a16:creationId xmlns:a16="http://schemas.microsoft.com/office/drawing/2014/main" id="{6EF8AABC-46BD-53C5-5E20-392662D36EE2}"/>
                  </a:ext>
                </a:extLst>
              </p:cNvPr>
              <p:cNvSpPr/>
              <p:nvPr/>
            </p:nvSpPr>
            <p:spPr>
              <a:xfrm flipV="1">
                <a:off x="6293449" y="1629524"/>
                <a:ext cx="1499997" cy="41871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8211CBC9-EBB9-E1D9-00FA-4A17A644AA13}"/>
              </a:ext>
            </a:extLst>
          </p:cNvPr>
          <p:cNvGrpSpPr/>
          <p:nvPr/>
        </p:nvGrpSpPr>
        <p:grpSpPr>
          <a:xfrm>
            <a:off x="7313583" y="2258065"/>
            <a:ext cx="2433856" cy="4437017"/>
            <a:chOff x="7743902" y="2232443"/>
            <a:chExt cx="2433856" cy="4437017"/>
          </a:xfrm>
        </p:grpSpPr>
        <p:pic>
          <p:nvPicPr>
            <p:cNvPr id="7" name="Picture 6" descr="A close-up of a test&#10;&#10;AI-generated content may be incorrect.">
              <a:extLst>
                <a:ext uri="{FF2B5EF4-FFF2-40B4-BE49-F238E27FC236}">
                  <a16:creationId xmlns:a16="http://schemas.microsoft.com/office/drawing/2014/main" id="{0A522451-C1DA-95BB-4E2B-86BA61EBA9B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6915" t="1448" r="8925" b="-1138"/>
            <a:stretch/>
          </p:blipFill>
          <p:spPr>
            <a:xfrm>
              <a:off x="8218515" y="3010830"/>
              <a:ext cx="1959243" cy="3106465"/>
            </a:xfrm>
            <a:prstGeom prst="rect">
              <a:avLst/>
            </a:prstGeom>
          </p:spPr>
        </p:pic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288DB193-4C90-9488-B510-88C820337011}"/>
                </a:ext>
              </a:extLst>
            </p:cNvPr>
            <p:cNvGrpSpPr/>
            <p:nvPr/>
          </p:nvGrpSpPr>
          <p:grpSpPr>
            <a:xfrm>
              <a:off x="7743902" y="2232443"/>
              <a:ext cx="2252118" cy="4437017"/>
              <a:chOff x="5863767" y="2005155"/>
              <a:chExt cx="2252118" cy="4437017"/>
            </a:xfrm>
          </p:grpSpPr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071A281F-0E29-6DA3-7BC5-F8E1720D4ABB}"/>
                  </a:ext>
                </a:extLst>
              </p:cNvPr>
              <p:cNvSpPr txBox="1"/>
              <p:nvPr/>
            </p:nvSpPr>
            <p:spPr>
              <a:xfrm rot="18528072">
                <a:off x="6210189" y="2215149"/>
                <a:ext cx="75854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>
                    <a:solidFill>
                      <a:srgbClr val="C00000"/>
                    </a:solidFill>
                  </a:rPr>
                  <a:t>Ladder</a:t>
                </a:r>
              </a:p>
            </p:txBody>
          </p:sp>
          <p:sp>
            <p:nvSpPr>
              <p:cNvPr id="51" name="ZoneTexte 32">
                <a:extLst>
                  <a:ext uri="{FF2B5EF4-FFF2-40B4-BE49-F238E27FC236}">
                    <a16:creationId xmlns:a16="http://schemas.microsoft.com/office/drawing/2014/main" id="{1F6B99D2-19F8-E48A-88AB-B9DD61E5B088}"/>
                  </a:ext>
                </a:extLst>
              </p:cNvPr>
              <p:cNvSpPr txBox="1"/>
              <p:nvPr/>
            </p:nvSpPr>
            <p:spPr>
              <a:xfrm>
                <a:off x="6225303" y="5795841"/>
                <a:ext cx="1890582" cy="646331"/>
              </a:xfrm>
              <a:prstGeom prst="rect">
                <a:avLst/>
              </a:prstGeom>
              <a:noFill/>
            </p:spPr>
            <p:txBody>
              <a:bodyPr wrap="none" lIns="91440" tIns="45720" rIns="91440" bIns="45720" rtlCol="0" anchor="t">
                <a:spAutoFit/>
              </a:bodyPr>
              <a:lstStyle/>
              <a:p>
                <a:r>
                  <a:rPr lang="el-GR" sz="1200"/>
                  <a:t>α</a:t>
                </a:r>
                <a:r>
                  <a:rPr lang="fr-FR" sz="1200"/>
                  <a:t>-</a:t>
                </a:r>
                <a:r>
                  <a:rPr lang="en-GB" sz="1200"/>
                  <a:t>pSTAT3 Blot</a:t>
                </a:r>
                <a:endParaRPr lang="en-US"/>
              </a:p>
              <a:p>
                <a:r>
                  <a:rPr lang="fr-FR" sz="1200"/>
                  <a:t>Chemiluminescence image </a:t>
                </a:r>
                <a:br>
                  <a:rPr lang="el-GR" sz="1200"/>
                </a:br>
                <a:r>
                  <a:rPr lang="fr-FR" sz="1200"/>
                  <a:t>+ Membrane overlay</a:t>
                </a:r>
                <a:endParaRPr lang="fr-FR"/>
              </a:p>
            </p:txBody>
          </p: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555C4696-2FDB-CC83-96D7-46B552B8F8C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22785" y="5030889"/>
                <a:ext cx="208961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AB651085-81D5-DF3A-E28E-E57B3D611170}"/>
                  </a:ext>
                </a:extLst>
              </p:cNvPr>
              <p:cNvSpPr txBox="1"/>
              <p:nvPr/>
            </p:nvSpPr>
            <p:spPr>
              <a:xfrm>
                <a:off x="5865523" y="4861612"/>
                <a:ext cx="495647" cy="338554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r>
                  <a:rPr lang="en-US" sz="1600"/>
                  <a:t>25</a:t>
                </a:r>
              </a:p>
            </p:txBody>
          </p: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E358D0A4-42ED-3A4A-DA55-05DE297724E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24220" y="4753802"/>
                <a:ext cx="208961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70516E9B-E49F-F821-D9F0-4AE574C34A96}"/>
                  </a:ext>
                </a:extLst>
              </p:cNvPr>
              <p:cNvSpPr txBox="1"/>
              <p:nvPr/>
            </p:nvSpPr>
            <p:spPr>
              <a:xfrm>
                <a:off x="5866958" y="4584525"/>
                <a:ext cx="49564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/>
                  <a:t>37</a:t>
                </a:r>
              </a:p>
            </p:txBody>
          </p: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E1916232-78F8-B852-E313-955A04B3E2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22785" y="4423057"/>
                <a:ext cx="208961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977A1412-9879-16EF-3FDD-99232DE7D37D}"/>
                  </a:ext>
                </a:extLst>
              </p:cNvPr>
              <p:cNvSpPr txBox="1"/>
              <p:nvPr/>
            </p:nvSpPr>
            <p:spPr>
              <a:xfrm>
                <a:off x="5865523" y="4253780"/>
                <a:ext cx="49564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/>
                  <a:t>50</a:t>
                </a:r>
              </a:p>
            </p:txBody>
          </p:sp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id="{6A72BB14-4305-17AF-B1D2-2F57592C2F9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21029" y="3973460"/>
                <a:ext cx="208961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50B41220-920F-5AA2-8EE2-16AE90C9EBCF}"/>
                  </a:ext>
                </a:extLst>
              </p:cNvPr>
              <p:cNvSpPr txBox="1"/>
              <p:nvPr/>
            </p:nvSpPr>
            <p:spPr>
              <a:xfrm>
                <a:off x="5863767" y="3804183"/>
                <a:ext cx="49564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/>
                  <a:t>75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4852865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2</Words>
  <Application>Microsoft Macintosh PowerPoint</Application>
  <PresentationFormat>Widescreen</PresentationFormat>
  <Paragraphs>8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Wingdings</vt:lpstr>
      <vt:lpstr>Thème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almonella Infection for SteE mutants : WT / L89A / G90A / P92A / LGP-AAA</dc:title>
  <dc:creator>Alexi RONNEAU</dc:creator>
  <cp:lastModifiedBy>Thurston, Teresa L M</cp:lastModifiedBy>
  <cp:revision>2</cp:revision>
  <dcterms:created xsi:type="dcterms:W3CDTF">2025-03-06T18:55:09Z</dcterms:created>
  <dcterms:modified xsi:type="dcterms:W3CDTF">2025-03-17T09:36:45Z</dcterms:modified>
</cp:coreProperties>
</file>